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8" d="100"/>
          <a:sy n="118" d="100"/>
        </p:scale>
        <p:origin x="1666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5025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35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4626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9972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2253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3982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119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388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7325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5535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9317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0B76E-47D0-4AE4-A635-D714A7CF449C}" type="datetimeFigureOut">
              <a:rPr lang="it-IT" smtClean="0"/>
              <a:t>04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2FD27-CADD-49C8-BDD1-A02E577DA4E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6744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\\VERSADOC\VersaDoc - users\Valentina\mutants\screening\2004-11-24 ccd8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3467" y="533400"/>
            <a:ext cx="5480216" cy="36560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CasellaDiTesto 4"/>
          <p:cNvSpPr txBox="1"/>
          <p:nvPr/>
        </p:nvSpPr>
        <p:spPr>
          <a:xfrm>
            <a:off x="2284676" y="112498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1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2535730" y="110321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2</a:t>
            </a:r>
            <a:endParaRPr lang="it-IT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2776737" y="110321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3</a:t>
            </a:r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016853" y="1125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4</a:t>
            </a:r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3277128" y="11261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5</a:t>
            </a:r>
            <a:endParaRPr lang="it-IT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815617" y="11261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6</a:t>
            </a:r>
            <a:endParaRPr lang="it-IT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4069517" y="113587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7</a:t>
            </a:r>
            <a:endParaRPr lang="it-IT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4295254" y="116813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8</a:t>
            </a:r>
            <a:endParaRPr lang="it-IT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4533556" y="113587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9</a:t>
            </a:r>
            <a:endParaRPr lang="it-IT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4746031" y="113548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10</a:t>
            </a:r>
            <a:endParaRPr lang="it-IT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3555006" y="11681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+</a:t>
            </a:r>
            <a:endParaRPr lang="it-IT" b="1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5804869" y="1171602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-</a:t>
            </a:r>
            <a:endParaRPr lang="it-IT" b="1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2274729" y="29488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1</a:t>
            </a:r>
            <a:endParaRPr lang="it-IT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2553881" y="29488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2</a:t>
            </a:r>
            <a:endParaRPr lang="it-IT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2786286" y="29488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3</a:t>
            </a:r>
            <a:endParaRPr lang="it-IT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3033297" y="29488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4</a:t>
            </a:r>
            <a:endParaRPr lang="it-IT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3276226" y="29335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5</a:t>
            </a:r>
            <a:endParaRPr lang="it-IT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3567134" y="293499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6</a:t>
            </a:r>
            <a:endParaRPr lang="it-IT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3819392" y="292077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7</a:t>
            </a:r>
            <a:endParaRPr lang="it-IT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4055933" y="29335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8</a:t>
            </a:r>
            <a:endParaRPr lang="it-IT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4338556" y="294548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9</a:t>
            </a:r>
            <a:endParaRPr lang="it-IT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4549906" y="294362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10</a:t>
            </a:r>
            <a:endParaRPr lang="it-IT" dirty="0"/>
          </a:p>
        </p:txBody>
      </p:sp>
      <p:sp>
        <p:nvSpPr>
          <p:cNvPr id="29" name="Rettangolo 28"/>
          <p:cNvSpPr/>
          <p:nvPr/>
        </p:nvSpPr>
        <p:spPr>
          <a:xfrm>
            <a:off x="4295254" y="914400"/>
            <a:ext cx="301686" cy="14470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1" name="Rettangolo 30"/>
          <p:cNvSpPr/>
          <p:nvPr/>
        </p:nvSpPr>
        <p:spPr>
          <a:xfrm>
            <a:off x="4069517" y="2723909"/>
            <a:ext cx="301686" cy="14470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2" name="Rettangolo 31"/>
          <p:cNvSpPr/>
          <p:nvPr/>
        </p:nvSpPr>
        <p:spPr>
          <a:xfrm>
            <a:off x="4825978" y="914399"/>
            <a:ext cx="301686" cy="1447043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3" name="Rettangolo 32"/>
          <p:cNvSpPr/>
          <p:nvPr/>
        </p:nvSpPr>
        <p:spPr>
          <a:xfrm>
            <a:off x="4620355" y="2714139"/>
            <a:ext cx="301686" cy="1447043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rgbClr val="FF0000"/>
              </a:solidFill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3485451" y="348734"/>
            <a:ext cx="2447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Screening of </a:t>
            </a:r>
            <a:r>
              <a:rPr lang="it-IT" i="1" dirty="0" smtClean="0"/>
              <a:t>zas</a:t>
            </a:r>
            <a:r>
              <a:rPr lang="it-IT" dirty="0" smtClean="0"/>
              <a:t> mutant</a:t>
            </a:r>
            <a:endParaRPr lang="it-IT" dirty="0"/>
          </a:p>
        </p:txBody>
      </p:sp>
      <p:cxnSp>
        <p:nvCxnSpPr>
          <p:cNvPr id="36" name="Connettore 1 35"/>
          <p:cNvCxnSpPr/>
          <p:nvPr/>
        </p:nvCxnSpPr>
        <p:spPr>
          <a:xfrm>
            <a:off x="1752600" y="914399"/>
            <a:ext cx="0" cy="17997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36"/>
          <p:cNvSpPr txBox="1"/>
          <p:nvPr/>
        </p:nvSpPr>
        <p:spPr>
          <a:xfrm>
            <a:off x="152400" y="1309653"/>
            <a:ext cx="14544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 smtClean="0"/>
              <a:t>Amplification</a:t>
            </a:r>
            <a:r>
              <a:rPr lang="it-IT" sz="1400" dirty="0" smtClean="0"/>
              <a:t> with</a:t>
            </a:r>
          </a:p>
          <a:p>
            <a:pPr algn="ctr"/>
            <a:r>
              <a:rPr lang="it-IT" sz="1400" dirty="0" err="1" smtClean="0"/>
              <a:t>Zas</a:t>
            </a:r>
            <a:r>
              <a:rPr lang="it-IT" sz="1400" dirty="0" smtClean="0"/>
              <a:t> For + </a:t>
            </a:r>
            <a:r>
              <a:rPr lang="it-IT" sz="1400" dirty="0" err="1" smtClean="0"/>
              <a:t>zas</a:t>
            </a:r>
            <a:r>
              <a:rPr lang="it-IT" sz="1400" dirty="0" smtClean="0"/>
              <a:t> </a:t>
            </a:r>
            <a:r>
              <a:rPr lang="it-IT" sz="1400" dirty="0" err="1" smtClean="0"/>
              <a:t>Rev</a:t>
            </a:r>
            <a:r>
              <a:rPr lang="it-IT" sz="1400" dirty="0" smtClean="0"/>
              <a:t> </a:t>
            </a:r>
            <a:endParaRPr lang="it-IT" sz="1400" dirty="0"/>
          </a:p>
        </p:txBody>
      </p:sp>
      <p:cxnSp>
        <p:nvCxnSpPr>
          <p:cNvPr id="38" name="Connettore 1 37"/>
          <p:cNvCxnSpPr/>
          <p:nvPr/>
        </p:nvCxnSpPr>
        <p:spPr>
          <a:xfrm>
            <a:off x="1752600" y="2866539"/>
            <a:ext cx="0" cy="13229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sellaDiTesto 38"/>
          <p:cNvSpPr txBox="1"/>
          <p:nvPr/>
        </p:nvSpPr>
        <p:spPr>
          <a:xfrm>
            <a:off x="152400" y="3105436"/>
            <a:ext cx="1600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 smtClean="0"/>
              <a:t>Amplification</a:t>
            </a:r>
            <a:r>
              <a:rPr lang="it-IT" sz="1400" dirty="0" smtClean="0"/>
              <a:t> with</a:t>
            </a:r>
          </a:p>
          <a:p>
            <a:pPr algn="ctr"/>
            <a:r>
              <a:rPr lang="it-IT" sz="1400" dirty="0" err="1" smtClean="0"/>
              <a:t>Zas</a:t>
            </a:r>
            <a:r>
              <a:rPr lang="it-IT" sz="1400" dirty="0" smtClean="0"/>
              <a:t> For </a:t>
            </a:r>
            <a:r>
              <a:rPr lang="it-IT" sz="1400" smtClean="0"/>
              <a:t>+ Tos17 Rev</a:t>
            </a:r>
            <a:r>
              <a:rPr lang="it-IT" sz="1400" dirty="0" smtClean="0"/>
              <a:t> </a:t>
            </a:r>
            <a:endParaRPr lang="it-IT" sz="14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2289589" y="5943600"/>
            <a:ext cx="5014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Plant</a:t>
            </a:r>
            <a:r>
              <a:rPr lang="it-IT" b="1" dirty="0" smtClean="0"/>
              <a:t> 8 and </a:t>
            </a:r>
            <a:r>
              <a:rPr lang="it-IT" b="1" dirty="0" err="1" smtClean="0"/>
              <a:t>plant</a:t>
            </a:r>
            <a:r>
              <a:rPr lang="it-IT" b="1" dirty="0" smtClean="0"/>
              <a:t> 10 are </a:t>
            </a:r>
            <a:r>
              <a:rPr lang="it-IT" b="1" dirty="0" err="1" smtClean="0"/>
              <a:t>homozygous</a:t>
            </a:r>
            <a:r>
              <a:rPr lang="it-IT" b="1" dirty="0" smtClean="0"/>
              <a:t> </a:t>
            </a:r>
            <a:r>
              <a:rPr lang="it-IT" b="1" dirty="0" err="1" smtClean="0"/>
              <a:t>mutant</a:t>
            </a:r>
            <a:r>
              <a:rPr lang="it-IT" b="1" dirty="0" smtClean="0"/>
              <a:t> </a:t>
            </a:r>
            <a:r>
              <a:rPr lang="it-IT" b="1" dirty="0" err="1" smtClean="0"/>
              <a:t>lines</a:t>
            </a:r>
            <a:r>
              <a:rPr lang="it-IT" b="1" dirty="0" smtClean="0"/>
              <a:t> </a:t>
            </a:r>
            <a:endParaRPr lang="it-IT" b="1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292400" y="4525314"/>
            <a:ext cx="562660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From 1 to 10: </a:t>
            </a:r>
            <a:r>
              <a:rPr lang="it-IT" dirty="0" err="1" smtClean="0"/>
              <a:t>different</a:t>
            </a:r>
            <a:r>
              <a:rPr lang="it-IT" dirty="0" smtClean="0"/>
              <a:t>  </a:t>
            </a:r>
            <a:r>
              <a:rPr lang="it-IT" dirty="0" err="1" smtClean="0"/>
              <a:t>rice</a:t>
            </a:r>
            <a:r>
              <a:rPr lang="it-IT" dirty="0" smtClean="0"/>
              <a:t> </a:t>
            </a:r>
            <a:r>
              <a:rPr lang="it-IT" dirty="0" err="1" smtClean="0"/>
              <a:t>plants</a:t>
            </a:r>
            <a:r>
              <a:rPr lang="it-IT" dirty="0" smtClean="0"/>
              <a:t> </a:t>
            </a:r>
            <a:r>
              <a:rPr lang="it-IT" dirty="0" err="1" smtClean="0"/>
              <a:t>using</a:t>
            </a:r>
            <a:r>
              <a:rPr lang="it-IT" dirty="0" smtClean="0"/>
              <a:t> for the screening </a:t>
            </a:r>
            <a:endParaRPr lang="it-IT" dirty="0"/>
          </a:p>
          <a:p>
            <a:r>
              <a:rPr lang="it-IT" dirty="0" smtClean="0"/>
              <a:t>+: positive control</a:t>
            </a:r>
          </a:p>
          <a:p>
            <a:r>
              <a:rPr lang="it-IT" dirty="0" smtClean="0"/>
              <a:t>-: Negative control</a:t>
            </a:r>
            <a:endParaRPr lang="it-IT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5282514" y="11681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+</a:t>
            </a:r>
            <a:endParaRPr lang="it-IT" b="1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5120563" y="305780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-</a:t>
            </a:r>
            <a:endParaRPr lang="it-IT" b="1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5528161" y="3058001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-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3628624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70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Valentina</dc:creator>
  <cp:lastModifiedBy>Imran Haider</cp:lastModifiedBy>
  <cp:revision>8</cp:revision>
  <dcterms:created xsi:type="dcterms:W3CDTF">2018-02-15T10:01:43Z</dcterms:created>
  <dcterms:modified xsi:type="dcterms:W3CDTF">2018-12-04T10:02:40Z</dcterms:modified>
</cp:coreProperties>
</file>